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B556801-3D92-4853-83BF-34F2BE8DA9E4}" v="6" dt="2022-02-21T15:14:34.67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2" d="100"/>
          <a:sy n="72" d="100"/>
        </p:scale>
        <p:origin x="660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43CBE8-32B1-4B3F-BDD2-7B27BE7F371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E6545CB-6BD1-420E-8C7A-6A41495B104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4553A7-D68D-4048-9E3B-5CDEAB7DC3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9E150-69EE-48DC-98C9-4C1889E782F2}" type="datetimeFigureOut">
              <a:rPr lang="en-GB" smtClean="0"/>
              <a:t>22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B705F8-8B21-40A7-AA63-89EE3FCB00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8324B8-CDE1-4075-9D9D-F296414907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210A5-3861-4AF2-BEBE-CF20FFF5D5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53669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6D2C80-CF72-4AD1-8AEB-645C1A4981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777DA84-D9ED-4A90-9BE6-0B402C70C4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EB446B-4166-4952-94B2-FB4ADE7215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9E150-69EE-48DC-98C9-4C1889E782F2}" type="datetimeFigureOut">
              <a:rPr lang="en-GB" smtClean="0"/>
              <a:t>22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E3411A-F498-4ADD-854D-8430DC3E62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04C467-A2F7-4CAA-B28C-05424994DA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210A5-3861-4AF2-BEBE-CF20FFF5D5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32111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E35DFF0-93FD-46FF-9D1E-F400A975C0F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701A5C7-7DDB-490E-A551-7009A7C1F70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069A68-3055-4DD5-BFD7-77AAFA0E6F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9E150-69EE-48DC-98C9-4C1889E782F2}" type="datetimeFigureOut">
              <a:rPr lang="en-GB" smtClean="0"/>
              <a:t>22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0D6364-83FE-4EB8-8A80-36289F65C0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7732EE2-7BE8-459D-A54B-199A104FB0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210A5-3861-4AF2-BEBE-CF20FFF5D5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82119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A1B500-84C6-4D49-824E-9967D51BAE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1EE8915-2041-43BA-9BE2-F0A36DDB768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75F51C-1458-4B57-83AC-F21867EC94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9E150-69EE-48DC-98C9-4C1889E782F2}" type="datetimeFigureOut">
              <a:rPr lang="en-GB" smtClean="0"/>
              <a:t>22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8F65BF-DADF-4F2B-AE0B-8D19222200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1CC60D-F0A5-4D57-BB15-07A87DE1F4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210A5-3861-4AF2-BEBE-CF20FFF5D5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97741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59B101-E175-4FDB-A048-C2BE8C8AE4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A14F478-1B96-4F14-8B20-F7F945A972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9CA6B7-409A-4230-9C60-34E930FEB9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9E150-69EE-48DC-98C9-4C1889E782F2}" type="datetimeFigureOut">
              <a:rPr lang="en-GB" smtClean="0"/>
              <a:t>22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A42CA0-92DF-4742-83DF-3FE51532F0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9BD63E-3717-4786-82DC-0D1A4E2814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210A5-3861-4AF2-BEBE-CF20FFF5D5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95840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8D092D-97E1-4CE1-88A4-B64A41EE4D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96F1A54-36FE-4ADF-BCDD-2DB38C93008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CDB2399-B673-49CC-883C-3691BCDE05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DBE7AB2-4AD1-480A-B1D2-6E4021F789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9E150-69EE-48DC-98C9-4C1889E782F2}" type="datetimeFigureOut">
              <a:rPr lang="en-GB" smtClean="0"/>
              <a:t>22/02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4C2FD76-F271-4787-AA9C-3A4F4E1513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E7E43CD-E014-488C-BDD9-0717D682A0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210A5-3861-4AF2-BEBE-CF20FFF5D5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7858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5FB3E6-61B4-42AA-A5D7-321953F592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91FB330-BE6F-4CD5-8CED-98EC0B5747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7F38A22-4C00-4AC5-AC51-C3EDC955B08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5E81E9C-0042-408C-80D2-7132F1C3248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24C6835-AF20-440A-94E7-866A44D1BEC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ECFCE8A-4EE2-4AA1-BE1C-8845ACA000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9E150-69EE-48DC-98C9-4C1889E782F2}" type="datetimeFigureOut">
              <a:rPr lang="en-GB" smtClean="0"/>
              <a:t>22/02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405485D-A87E-457F-84B6-9AEEC5C27C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9173719-8DAD-4CC5-B3E0-2B87A77EFA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210A5-3861-4AF2-BEBE-CF20FFF5D5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694818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A429A7-1ACF-45D2-A334-135AAE695A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22A14BA-577D-4934-8D63-ECFEE80C01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9E150-69EE-48DC-98C9-4C1889E782F2}" type="datetimeFigureOut">
              <a:rPr lang="en-GB" smtClean="0"/>
              <a:t>22/02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B19E9DB-2EEB-4046-BAA3-B50B9EAB75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B9A7237-E707-4C00-829C-0A030ECD30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210A5-3861-4AF2-BEBE-CF20FFF5D5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22315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E9C0305-4741-4E86-9766-C836DFC0BB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9E150-69EE-48DC-98C9-4C1889E782F2}" type="datetimeFigureOut">
              <a:rPr lang="en-GB" smtClean="0"/>
              <a:t>22/02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CBF3EA6-8ACF-4A6F-8DC7-C232C8D87F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A50D4FA-4E7C-45EB-86BE-0F8BF68E24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210A5-3861-4AF2-BEBE-CF20FFF5D5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82847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596B04-706A-4248-A9F1-968E875E19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568360A-7C72-42C7-B9BA-B1DD5295CFD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598871F-107C-4DE1-8BC9-EF20E8D51BA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17A19C3-0F1B-4D65-97B4-3EDF636478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9E150-69EE-48DC-98C9-4C1889E782F2}" type="datetimeFigureOut">
              <a:rPr lang="en-GB" smtClean="0"/>
              <a:t>22/02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BF5728A-26FB-4F25-9BFE-E765F3A26C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1CDCEB1-C1B0-4197-A93D-8856DB750B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210A5-3861-4AF2-BEBE-CF20FFF5D5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099909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BB5A0E-B5AB-460E-A23A-838F521B00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7DEE561-4E0E-4E3A-8D29-53281AF7A86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6F46C47-FED0-400E-8DA2-C3E328283F9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BBDB1E1-ADB0-448A-8843-2645FCDE32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9E150-69EE-48DC-98C9-4C1889E782F2}" type="datetimeFigureOut">
              <a:rPr lang="en-GB" smtClean="0"/>
              <a:t>22/02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5D8BB7-B0E5-4FC8-AC08-99EB865C16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361FA90-B5E8-4F37-87C9-3D4848121C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210A5-3861-4AF2-BEBE-CF20FFF5D5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41663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ED29E9C-63EF-4F10-BF5D-DA69D30E5F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502CBA6-E186-4374-8C48-B3D133C47C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08F0C5-1A86-4E0E-B087-384A924037B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49E150-69EE-48DC-98C9-4C1889E782F2}" type="datetimeFigureOut">
              <a:rPr lang="en-GB" smtClean="0"/>
              <a:t>22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D3F7CE-FCD3-466C-BE62-C54FC0B38BB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3CAF4E-5D7E-427B-BBA1-F176169EAB7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4210A5-3861-4AF2-BEBE-CF20FFF5D5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79864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TI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TextBox 39">
            <a:extLst>
              <a:ext uri="{FF2B5EF4-FFF2-40B4-BE49-F238E27FC236}">
                <a16:creationId xmlns:a16="http://schemas.microsoft.com/office/drawing/2014/main" id="{F2B5C872-D29F-49D7-A68D-61A2C29325E2}"/>
              </a:ext>
            </a:extLst>
          </p:cNvPr>
          <p:cNvSpPr txBox="1"/>
          <p:nvPr/>
        </p:nvSpPr>
        <p:spPr>
          <a:xfrm>
            <a:off x="324331" y="77672"/>
            <a:ext cx="17892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Additional File  7</a:t>
            </a:r>
          </a:p>
        </p:txBody>
      </p:sp>
      <p:pic>
        <p:nvPicPr>
          <p:cNvPr id="46" name="Picture 45">
            <a:extLst>
              <a:ext uri="{FF2B5EF4-FFF2-40B4-BE49-F238E27FC236}">
                <a16:creationId xmlns:a16="http://schemas.microsoft.com/office/drawing/2014/main" id="{7198EAC3-8D41-4EB2-9EFC-A526377F1F8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8669" y="515301"/>
            <a:ext cx="2130737" cy="2353260"/>
          </a:xfrm>
          <a:prstGeom prst="rect">
            <a:avLst/>
          </a:prstGeom>
        </p:spPr>
      </p:pic>
      <p:pic>
        <p:nvPicPr>
          <p:cNvPr id="93" name="Picture 92">
            <a:extLst>
              <a:ext uri="{FF2B5EF4-FFF2-40B4-BE49-F238E27FC236}">
                <a16:creationId xmlns:a16="http://schemas.microsoft.com/office/drawing/2014/main" id="{6303CE38-8016-4B00-AEAD-CBCDC4F3D97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66569" y="216429"/>
            <a:ext cx="1262831" cy="5070678"/>
          </a:xfrm>
          <a:prstGeom prst="rect">
            <a:avLst/>
          </a:prstGeom>
        </p:spPr>
      </p:pic>
      <p:pic>
        <p:nvPicPr>
          <p:cNvPr id="126" name="Picture 125">
            <a:extLst>
              <a:ext uri="{FF2B5EF4-FFF2-40B4-BE49-F238E27FC236}">
                <a16:creationId xmlns:a16="http://schemas.microsoft.com/office/drawing/2014/main" id="{44711494-C520-4208-B6B9-9378376D1FB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29400" y="515301"/>
            <a:ext cx="1234415" cy="4031211"/>
          </a:xfrm>
          <a:prstGeom prst="rect">
            <a:avLst/>
          </a:prstGeom>
        </p:spPr>
      </p:pic>
      <p:pic>
        <p:nvPicPr>
          <p:cNvPr id="192" name="Picture 191">
            <a:extLst>
              <a:ext uri="{FF2B5EF4-FFF2-40B4-BE49-F238E27FC236}">
                <a16:creationId xmlns:a16="http://schemas.microsoft.com/office/drawing/2014/main" id="{4917045C-2E64-43BA-89FF-ACD133DE8C3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387467" y="327173"/>
            <a:ext cx="1417066" cy="6530827"/>
          </a:xfrm>
          <a:prstGeom prst="rect">
            <a:avLst/>
          </a:prstGeom>
        </p:spPr>
      </p:pic>
      <p:pic>
        <p:nvPicPr>
          <p:cNvPr id="225" name="Picture 224">
            <a:extLst>
              <a:ext uri="{FF2B5EF4-FFF2-40B4-BE49-F238E27FC236}">
                <a16:creationId xmlns:a16="http://schemas.microsoft.com/office/drawing/2014/main" id="{CBFA1375-1AC8-40F1-A091-E4EAC8406E9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804533" y="515301"/>
            <a:ext cx="1273793" cy="2593659"/>
          </a:xfrm>
          <a:prstGeom prst="rect">
            <a:avLst/>
          </a:prstGeom>
        </p:spPr>
      </p:pic>
      <p:pic>
        <p:nvPicPr>
          <p:cNvPr id="3" name="Picture 2" descr="A white rectangular object&#10;&#10;Description automatically generated with low confidence">
            <a:extLst>
              <a:ext uri="{FF2B5EF4-FFF2-40B4-BE49-F238E27FC236}">
                <a16:creationId xmlns:a16="http://schemas.microsoft.com/office/drawing/2014/main" id="{DE5CB358-9BD4-446E-91E8-CCE8E8BBC308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113" r="35677"/>
          <a:stretch/>
        </p:blipFill>
        <p:spPr>
          <a:xfrm>
            <a:off x="6804533" y="3248189"/>
            <a:ext cx="1273793" cy="2311487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6DF9F8B7-67A7-4A98-A84E-01722E2C75DF}"/>
              </a:ext>
            </a:extLst>
          </p:cNvPr>
          <p:cNvSpPr/>
          <p:nvPr/>
        </p:nvSpPr>
        <p:spPr>
          <a:xfrm>
            <a:off x="7150705" y="4468778"/>
            <a:ext cx="610697" cy="83869"/>
          </a:xfrm>
          <a:prstGeom prst="rect">
            <a:avLst/>
          </a:prstGeom>
          <a:noFill/>
          <a:ln w="9525">
            <a:solidFill>
              <a:srgbClr val="C0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05F55FF6-D600-406B-9F4F-9BACFF24CF9D}"/>
              </a:ext>
            </a:extLst>
          </p:cNvPr>
          <p:cNvSpPr/>
          <p:nvPr/>
        </p:nvSpPr>
        <p:spPr>
          <a:xfrm>
            <a:off x="7150705" y="4553768"/>
            <a:ext cx="610697" cy="439145"/>
          </a:xfrm>
          <a:prstGeom prst="rect">
            <a:avLst/>
          </a:prstGeom>
          <a:noFill/>
          <a:ln w="9525">
            <a:solidFill>
              <a:srgbClr val="C0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7FD2673-8151-4288-81F2-07AD4057C0CD}"/>
              </a:ext>
            </a:extLst>
          </p:cNvPr>
          <p:cNvSpPr txBox="1"/>
          <p:nvPr/>
        </p:nvSpPr>
        <p:spPr>
          <a:xfrm rot="16200000">
            <a:off x="7188423" y="3937899"/>
            <a:ext cx="57089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300" dirty="0"/>
              <a:t>U87</a:t>
            </a:r>
          </a:p>
          <a:p>
            <a:r>
              <a:rPr lang="en-GB" sz="300" dirty="0"/>
              <a:t>Control</a:t>
            </a:r>
          </a:p>
          <a:p>
            <a:endParaRPr lang="en-GB" sz="300" dirty="0"/>
          </a:p>
          <a:p>
            <a:r>
              <a:rPr lang="en-GB" sz="300" dirty="0"/>
              <a:t>U87</a:t>
            </a:r>
          </a:p>
          <a:p>
            <a:r>
              <a:rPr lang="en-GB" sz="300" dirty="0"/>
              <a:t>IC50 HTL-001</a:t>
            </a:r>
          </a:p>
          <a:p>
            <a:endParaRPr lang="en-GB" sz="300" dirty="0"/>
          </a:p>
          <a:p>
            <a:r>
              <a:rPr lang="en-GB" sz="300" dirty="0"/>
              <a:t>LN18</a:t>
            </a:r>
          </a:p>
          <a:p>
            <a:r>
              <a:rPr lang="en-GB" sz="300" dirty="0"/>
              <a:t>Control</a:t>
            </a:r>
          </a:p>
          <a:p>
            <a:endParaRPr lang="en-GB" sz="300" dirty="0"/>
          </a:p>
          <a:p>
            <a:r>
              <a:rPr lang="en-GB" sz="300" dirty="0"/>
              <a:t>LN18</a:t>
            </a:r>
          </a:p>
          <a:p>
            <a:r>
              <a:rPr lang="en-GB" sz="300" dirty="0"/>
              <a:t>IC50 HTL-001</a:t>
            </a:r>
          </a:p>
          <a:p>
            <a:endParaRPr lang="en-GB" sz="3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62B7580-3C93-4DA2-A456-BB024344779F}"/>
              </a:ext>
            </a:extLst>
          </p:cNvPr>
          <p:cNvSpPr txBox="1"/>
          <p:nvPr/>
        </p:nvSpPr>
        <p:spPr>
          <a:xfrm>
            <a:off x="7699084" y="4431384"/>
            <a:ext cx="57089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300" dirty="0"/>
              <a:t>Β</a:t>
            </a:r>
            <a:r>
              <a:rPr lang="en-GB" sz="300" dirty="0"/>
              <a:t>-actin</a:t>
            </a:r>
          </a:p>
          <a:p>
            <a:endParaRPr lang="en-GB" sz="300" dirty="0"/>
          </a:p>
          <a:p>
            <a:r>
              <a:rPr lang="en-GB" sz="300" dirty="0"/>
              <a:t>Caspase-3</a:t>
            </a:r>
          </a:p>
          <a:p>
            <a:endParaRPr lang="en-GB" sz="300" dirty="0"/>
          </a:p>
          <a:p>
            <a:endParaRPr lang="en-GB" sz="300" dirty="0"/>
          </a:p>
          <a:p>
            <a:endParaRPr lang="en-GB" sz="300" dirty="0"/>
          </a:p>
          <a:p>
            <a:r>
              <a:rPr lang="en-GB" sz="300" dirty="0"/>
              <a:t>Cleaved Caspase 3</a:t>
            </a:r>
          </a:p>
          <a:p>
            <a:endParaRPr lang="en-GB" sz="3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1BD094F-C863-4CB3-9592-58AD31D032DF}"/>
              </a:ext>
            </a:extLst>
          </p:cNvPr>
          <p:cNvSpPr txBox="1"/>
          <p:nvPr/>
        </p:nvSpPr>
        <p:spPr>
          <a:xfrm>
            <a:off x="6804533" y="3081644"/>
            <a:ext cx="6463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Caspase 3</a:t>
            </a:r>
          </a:p>
        </p:txBody>
      </p:sp>
    </p:spTree>
    <p:extLst>
      <p:ext uri="{BB962C8B-B14F-4D97-AF65-F5344CB8AC3E}">
        <p14:creationId xmlns:p14="http://schemas.microsoft.com/office/powerpoint/2010/main" val="6648780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90</TotalTime>
  <Words>21</Words>
  <Application>Microsoft Office PowerPoint</Application>
  <PresentationFormat>Widescreen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elph, Kate Dr (Sch of Biosci &amp; Med)</dc:creator>
  <cp:lastModifiedBy>Relph, Kate Dr (Sch of Biosci &amp; Med)</cp:lastModifiedBy>
  <cp:revision>3</cp:revision>
  <dcterms:created xsi:type="dcterms:W3CDTF">2021-07-20T08:13:14Z</dcterms:created>
  <dcterms:modified xsi:type="dcterms:W3CDTF">2022-02-22T09:03:43Z</dcterms:modified>
</cp:coreProperties>
</file>